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4"/>
  </p:notesMasterIdLst>
  <p:sldIdLst>
    <p:sldId id="276" r:id="rId2"/>
    <p:sldId id="277" r:id="rId3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lrMru>
    <a:srgbClr val="0000FF"/>
    <a:srgbClr val="1903BD"/>
  </p:clrMru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6985" autoAdjust="0"/>
    <p:restoredTop sz="94660"/>
  </p:normalViewPr>
  <p:slideViewPr>
    <p:cSldViewPr>
      <p:cViewPr varScale="1">
        <p:scale>
          <a:sx n="87" d="100"/>
          <a:sy n="87" d="100"/>
        </p:scale>
        <p:origin x="-2544" y="-12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/>
          <a:lstStyle>
            <a:lvl1pPr algn="r">
              <a:defRPr sz="1200"/>
            </a:lvl1pPr>
          </a:lstStyle>
          <a:p>
            <a:fld id="{CD13F842-1841-445C-9E98-A1A152CAE142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8" tIns="45719" rIns="91438" bIns="4571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vert="horz" lIns="91438" tIns="45719" rIns="91438" bIns="4571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29968"/>
            <a:ext cx="2971800" cy="464820"/>
          </a:xfrm>
          <a:prstGeom prst="rect">
            <a:avLst/>
          </a:prstGeom>
        </p:spPr>
        <p:txBody>
          <a:bodyPr vert="horz" lIns="91438" tIns="45719" rIns="91438" bIns="45719" rtlCol="0" anchor="b"/>
          <a:lstStyle>
            <a:lvl1pPr algn="r">
              <a:defRPr sz="1200"/>
            </a:lvl1pPr>
          </a:lstStyle>
          <a:p>
            <a:fld id="{EBA425D1-E6FE-412A-BEFE-860562746D1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84917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03397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58319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79202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26241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54018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85320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08489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421985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032642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32396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74239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75F38-005E-4A26-94C2-64A1E8A327F5}" type="datetimeFigureOut">
              <a:rPr lang="en-US" smtClean="0"/>
              <a:pPr/>
              <a:t>4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22D716-9C28-42B1-964D-7077D670B5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99033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76200" y="263123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4: Pathways significantly enriched based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on early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nutritional history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in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the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brain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76200" y="2008688"/>
            <a:ext cx="6616494" cy="5306512"/>
            <a:chOff x="76200" y="739914"/>
            <a:chExt cx="6616494" cy="5306512"/>
          </a:xfrm>
        </p:grpSpPr>
        <p:grpSp>
          <p:nvGrpSpPr>
            <p:cNvPr id="3" name="Group 2"/>
            <p:cNvGrpSpPr/>
            <p:nvPr/>
          </p:nvGrpSpPr>
          <p:grpSpPr>
            <a:xfrm>
              <a:off x="440103" y="927979"/>
              <a:ext cx="6098583" cy="5118447"/>
              <a:chOff x="440103" y="685800"/>
              <a:chExt cx="6098583" cy="5118447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66686" y="685800"/>
                <a:ext cx="4572000" cy="51184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0103" y="4364064"/>
                <a:ext cx="3124200" cy="10363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57201" y="2242443"/>
                <a:ext cx="1509486" cy="15545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9" name="Rectangle 8"/>
            <p:cNvSpPr/>
            <p:nvPr/>
          </p:nvSpPr>
          <p:spPr>
            <a:xfrm>
              <a:off x="76200" y="739914"/>
              <a:ext cx="6616494" cy="520368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76200" y="14478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Homocysteine metabolism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230264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2400" y="2057400"/>
            <a:ext cx="6616494" cy="5203686"/>
            <a:chOff x="152400" y="685800"/>
            <a:chExt cx="6616494" cy="5203686"/>
          </a:xfrm>
        </p:grpSpPr>
        <p:grpSp>
          <p:nvGrpSpPr>
            <p:cNvPr id="3" name="Group 2"/>
            <p:cNvGrpSpPr/>
            <p:nvPr/>
          </p:nvGrpSpPr>
          <p:grpSpPr>
            <a:xfrm>
              <a:off x="208181" y="685800"/>
              <a:ext cx="6497419" cy="5029200"/>
              <a:chOff x="41267" y="381000"/>
              <a:chExt cx="6816733" cy="5257801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1267" y="381000"/>
                <a:ext cx="5826133" cy="45577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410200" y="4148485"/>
                <a:ext cx="1447800" cy="14903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2400" y="4419600"/>
                <a:ext cx="1738313" cy="114881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9" name="Rectangle 8"/>
            <p:cNvSpPr/>
            <p:nvPr/>
          </p:nvSpPr>
          <p:spPr>
            <a:xfrm>
              <a:off x="152400" y="685800"/>
              <a:ext cx="6616494" cy="520368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76200" y="263123"/>
            <a:ext cx="62484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Additional File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4: Pathways significantly enriched based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on early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nutritional history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in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the </a:t>
            </a: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brain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6200" y="1447800"/>
            <a:ext cx="3810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 fontAlgn="base">
              <a:spcBef>
                <a:spcPct val="0"/>
              </a:spcBef>
              <a:spcAft>
                <a:spcPct val="0"/>
              </a:spcAft>
            </a:pPr>
            <a:r>
              <a:rPr lang="en-US" sz="1600" b="1" dirty="0" smtClean="0">
                <a:latin typeface="Arial" pitchFamily="34" charset="0"/>
                <a:ea typeface="ＭＳ Ｐゴシック" pitchFamily="34" charset="-128"/>
              </a:rPr>
              <a:t>Neuroendocrine peptides</a:t>
            </a:r>
            <a:endParaRPr lang="en-US" sz="1600" b="1" dirty="0">
              <a:latin typeface="Arial" pitchFamily="34" charset="0"/>
              <a:ea typeface="ＭＳ Ｐゴシック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74458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2</TotalTime>
  <Words>34</Words>
  <Application>Microsoft Macintosh PowerPoint</Application>
  <PresentationFormat>On-screen Show (4:3)</PresentationFormat>
  <Paragraphs>4</Paragraphs>
  <Slides>2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balasubram</dc:creator>
  <cp:lastModifiedBy>Mukundh</cp:lastModifiedBy>
  <cp:revision>114</cp:revision>
  <cp:lastPrinted>2014-08-04T13:17:26Z</cp:lastPrinted>
  <dcterms:created xsi:type="dcterms:W3CDTF">2016-04-14T00:36:40Z</dcterms:created>
  <dcterms:modified xsi:type="dcterms:W3CDTF">2016-04-14T00:47:18Z</dcterms:modified>
</cp:coreProperties>
</file>